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9" d="100"/>
          <a:sy n="59" d="100"/>
        </p:scale>
        <p:origin x="247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tin.Wubben\Documents\Research%20Projects\Reniform%20projects\Renbarb%20QTL%20analysis\RNA%20seq%20experiment\Sequence%20data\assembly%20annotation%20OUTPU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9447972329092528E-2"/>
          <c:y val="2.8534370946822308E-2"/>
          <c:w val="0.9150018626806109"/>
          <c:h val="0.9112885402943309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HISAT2 Chart'!$D$1</c:f>
              <c:strCache>
                <c:ptCount val="1"/>
                <c:pt idx="0">
                  <c:v>Multiple concordant matches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  <a:effectLst/>
          </c:spPr>
          <c:invertIfNegative val="0"/>
          <c:cat>
            <c:numRef>
              <c:f>'HISAT2 Chart'!$C$2:$C$25</c:f>
              <c:numCache>
                <c:formatCode>General</c:formatCode>
                <c:ptCount val="2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</c:numCache>
            </c:numRef>
          </c:cat>
          <c:val>
            <c:numRef>
              <c:f>'HISAT2 Chart'!$D$2:$D$25</c:f>
              <c:numCache>
                <c:formatCode>General</c:formatCode>
                <c:ptCount val="24"/>
                <c:pt idx="0">
                  <c:v>696.72299999999996</c:v>
                </c:pt>
                <c:pt idx="1">
                  <c:v>593.97299999999996</c:v>
                </c:pt>
                <c:pt idx="2">
                  <c:v>550.66800000000001</c:v>
                </c:pt>
                <c:pt idx="3">
                  <c:v>898.76599999999996</c:v>
                </c:pt>
                <c:pt idx="4">
                  <c:v>1146.03</c:v>
                </c:pt>
                <c:pt idx="5">
                  <c:v>741.09799999999996</c:v>
                </c:pt>
                <c:pt idx="6">
                  <c:v>1168.2360000000001</c:v>
                </c:pt>
                <c:pt idx="7">
                  <c:v>885.673</c:v>
                </c:pt>
                <c:pt idx="8">
                  <c:v>839.53499999999997</c:v>
                </c:pt>
                <c:pt idx="9">
                  <c:v>980.81200000000001</c:v>
                </c:pt>
                <c:pt idx="10">
                  <c:v>1050.0350000000001</c:v>
                </c:pt>
                <c:pt idx="11">
                  <c:v>688.78599999999994</c:v>
                </c:pt>
                <c:pt idx="12">
                  <c:v>518.25900000000001</c:v>
                </c:pt>
                <c:pt idx="13">
                  <c:v>558.55100000000004</c:v>
                </c:pt>
                <c:pt idx="14">
                  <c:v>627.64499999999998</c:v>
                </c:pt>
                <c:pt idx="15">
                  <c:v>903.62099999999998</c:v>
                </c:pt>
                <c:pt idx="16">
                  <c:v>1113.2049999999999</c:v>
                </c:pt>
                <c:pt idx="17">
                  <c:v>982.37099999999998</c:v>
                </c:pt>
                <c:pt idx="18">
                  <c:v>858.82299999999998</c:v>
                </c:pt>
                <c:pt idx="19">
                  <c:v>843.78899999999999</c:v>
                </c:pt>
                <c:pt idx="20">
                  <c:v>616.83000000000004</c:v>
                </c:pt>
                <c:pt idx="21">
                  <c:v>904.86199999999997</c:v>
                </c:pt>
                <c:pt idx="22">
                  <c:v>499.33800000000002</c:v>
                </c:pt>
                <c:pt idx="23">
                  <c:v>446.122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A8-4D98-ABBC-C461520B3691}"/>
            </c:ext>
          </c:extLst>
        </c:ser>
        <c:ser>
          <c:idx val="1"/>
          <c:order val="1"/>
          <c:tx>
            <c:strRef>
              <c:f>'HISAT2 Chart'!$E$1</c:f>
              <c:strCache>
                <c:ptCount val="1"/>
                <c:pt idx="0">
                  <c:v>Single concordant match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numRef>
              <c:f>'HISAT2 Chart'!$C$2:$C$25</c:f>
              <c:numCache>
                <c:formatCode>General</c:formatCode>
                <c:ptCount val="2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</c:numCache>
            </c:numRef>
          </c:cat>
          <c:val>
            <c:numRef>
              <c:f>'HISAT2 Chart'!$E$2:$E$25</c:f>
              <c:numCache>
                <c:formatCode>General</c:formatCode>
                <c:ptCount val="24"/>
                <c:pt idx="0">
                  <c:v>5927.2219999999998</c:v>
                </c:pt>
                <c:pt idx="1">
                  <c:v>5091.32</c:v>
                </c:pt>
                <c:pt idx="2">
                  <c:v>4546.473</c:v>
                </c:pt>
                <c:pt idx="3">
                  <c:v>7379.4520000000002</c:v>
                </c:pt>
                <c:pt idx="4">
                  <c:v>9043.34</c:v>
                </c:pt>
                <c:pt idx="5">
                  <c:v>5814.9750000000004</c:v>
                </c:pt>
                <c:pt idx="6">
                  <c:v>9112.1360000000004</c:v>
                </c:pt>
                <c:pt idx="7">
                  <c:v>6951.5259999999998</c:v>
                </c:pt>
                <c:pt idx="8">
                  <c:v>7280.0820000000003</c:v>
                </c:pt>
                <c:pt idx="9">
                  <c:v>8600.9230000000007</c:v>
                </c:pt>
                <c:pt idx="10">
                  <c:v>8813.5630000000001</c:v>
                </c:pt>
                <c:pt idx="11">
                  <c:v>6044.0889999999999</c:v>
                </c:pt>
                <c:pt idx="12">
                  <c:v>4475.4110000000001</c:v>
                </c:pt>
                <c:pt idx="13">
                  <c:v>4935.4669999999996</c:v>
                </c:pt>
                <c:pt idx="14">
                  <c:v>5356.277</c:v>
                </c:pt>
                <c:pt idx="15">
                  <c:v>7232.9669999999996</c:v>
                </c:pt>
                <c:pt idx="16">
                  <c:v>8902.5779999999995</c:v>
                </c:pt>
                <c:pt idx="17">
                  <c:v>7934.0479999999998</c:v>
                </c:pt>
                <c:pt idx="18">
                  <c:v>7374.152</c:v>
                </c:pt>
                <c:pt idx="19">
                  <c:v>7138.4809999999998</c:v>
                </c:pt>
                <c:pt idx="20">
                  <c:v>5450.3339999999998</c:v>
                </c:pt>
                <c:pt idx="21">
                  <c:v>7668.3810000000003</c:v>
                </c:pt>
                <c:pt idx="22">
                  <c:v>4442.7659999999996</c:v>
                </c:pt>
                <c:pt idx="23">
                  <c:v>405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A8-4D98-ABBC-C461520B3691}"/>
            </c:ext>
          </c:extLst>
        </c:ser>
        <c:ser>
          <c:idx val="2"/>
          <c:order val="2"/>
          <c:tx>
            <c:strRef>
              <c:f>'HISAT2 Chart'!$F$1</c:f>
              <c:strCache>
                <c:ptCount val="1"/>
                <c:pt idx="0">
                  <c:v>No concordant matches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numRef>
              <c:f>'HISAT2 Chart'!$C$2:$C$25</c:f>
              <c:numCache>
                <c:formatCode>General</c:formatCode>
                <c:ptCount val="2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</c:numCache>
            </c:numRef>
          </c:cat>
          <c:val>
            <c:numRef>
              <c:f>'HISAT2 Chart'!$F$2:$F$25</c:f>
              <c:numCache>
                <c:formatCode>General</c:formatCode>
                <c:ptCount val="24"/>
                <c:pt idx="0">
                  <c:v>640.34400000000005</c:v>
                </c:pt>
                <c:pt idx="1">
                  <c:v>535.49800000000005</c:v>
                </c:pt>
                <c:pt idx="2">
                  <c:v>514.59100000000001</c:v>
                </c:pt>
                <c:pt idx="3">
                  <c:v>797.89</c:v>
                </c:pt>
                <c:pt idx="4">
                  <c:v>980.56</c:v>
                </c:pt>
                <c:pt idx="5">
                  <c:v>632.69500000000005</c:v>
                </c:pt>
                <c:pt idx="6">
                  <c:v>1190.7239999999999</c:v>
                </c:pt>
                <c:pt idx="7">
                  <c:v>853.88400000000001</c:v>
                </c:pt>
                <c:pt idx="8">
                  <c:v>747.60299999999995</c:v>
                </c:pt>
                <c:pt idx="9">
                  <c:v>910.16600000000005</c:v>
                </c:pt>
                <c:pt idx="10">
                  <c:v>1005.5410000000001</c:v>
                </c:pt>
                <c:pt idx="11">
                  <c:v>810.86500000000001</c:v>
                </c:pt>
                <c:pt idx="12">
                  <c:v>652.94200000000001</c:v>
                </c:pt>
                <c:pt idx="13">
                  <c:v>696.63699999999994</c:v>
                </c:pt>
                <c:pt idx="14">
                  <c:v>1002.677</c:v>
                </c:pt>
                <c:pt idx="15">
                  <c:v>2096.3249999999998</c:v>
                </c:pt>
                <c:pt idx="16">
                  <c:v>864.25900000000001</c:v>
                </c:pt>
                <c:pt idx="17">
                  <c:v>859.19299999999998</c:v>
                </c:pt>
                <c:pt idx="18">
                  <c:v>850.55600000000004</c:v>
                </c:pt>
                <c:pt idx="19">
                  <c:v>773.40200000000004</c:v>
                </c:pt>
                <c:pt idx="20">
                  <c:v>1085.0260000000001</c:v>
                </c:pt>
                <c:pt idx="21">
                  <c:v>1328.549</c:v>
                </c:pt>
                <c:pt idx="22">
                  <c:v>1323.3820000000001</c:v>
                </c:pt>
                <c:pt idx="23">
                  <c:v>1427.122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8A8-4D98-ABBC-C461520B36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594048200"/>
        <c:axId val="594047544"/>
      </c:barChart>
      <c:catAx>
        <c:axId val="594048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94047544"/>
        <c:crosses val="autoZero"/>
        <c:auto val="1"/>
        <c:lblAlgn val="ctr"/>
        <c:lblOffset val="100"/>
        <c:tickMarkSkip val="2"/>
        <c:noMultiLvlLbl val="0"/>
      </c:catAx>
      <c:valAx>
        <c:axId val="5940475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9404820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661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11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512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581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565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887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313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187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4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936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094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3FB0F-9A98-44A3-A204-D6356572D19D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94271-83AE-4F0D-9F9C-771D6F913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486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30E32F0-20DA-3CEE-343A-5754914FADB3}"/>
              </a:ext>
            </a:extLst>
          </p:cNvPr>
          <p:cNvGrpSpPr/>
          <p:nvPr/>
        </p:nvGrpSpPr>
        <p:grpSpPr>
          <a:xfrm>
            <a:off x="275550" y="284527"/>
            <a:ext cx="6306899" cy="3529634"/>
            <a:chOff x="165259" y="480470"/>
            <a:chExt cx="6306899" cy="3529634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9A6567A-8A90-4900-9C12-5CB295763056}"/>
                </a:ext>
              </a:extLst>
            </p:cNvPr>
            <p:cNvGrpSpPr/>
            <p:nvPr/>
          </p:nvGrpSpPr>
          <p:grpSpPr>
            <a:xfrm>
              <a:off x="1249676" y="640080"/>
              <a:ext cx="1670525" cy="246221"/>
              <a:chOff x="2795452" y="4646023"/>
              <a:chExt cx="1670525" cy="246221"/>
            </a:xfrm>
          </p:grpSpPr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A3340D4B-6DB2-43EE-A2FA-14DDE387BE08}"/>
                  </a:ext>
                </a:extLst>
              </p:cNvPr>
              <p:cNvSpPr/>
              <p:nvPr/>
            </p:nvSpPr>
            <p:spPr>
              <a:xfrm>
                <a:off x="2795452" y="4708173"/>
                <a:ext cx="191589" cy="121920"/>
              </a:xfrm>
              <a:prstGeom prst="rect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879A546-CE5B-4E9B-B923-1AB2922D7593}"/>
                  </a:ext>
                </a:extLst>
              </p:cNvPr>
              <p:cNvSpPr txBox="1"/>
              <p:nvPr/>
            </p:nvSpPr>
            <p:spPr>
              <a:xfrm>
                <a:off x="2934789" y="4646023"/>
                <a:ext cx="1531188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 concordant matches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573F5F5-810D-4849-8CB4-D88D839441FD}"/>
                </a:ext>
              </a:extLst>
            </p:cNvPr>
            <p:cNvGrpSpPr/>
            <p:nvPr/>
          </p:nvGrpSpPr>
          <p:grpSpPr>
            <a:xfrm>
              <a:off x="2920201" y="640080"/>
              <a:ext cx="1726629" cy="246221"/>
              <a:chOff x="2145902" y="4744540"/>
              <a:chExt cx="1726629" cy="246221"/>
            </a:xfrm>
          </p:grpSpPr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38FF96D1-4A06-4DFA-B5AF-698D16136C68}"/>
                  </a:ext>
                </a:extLst>
              </p:cNvPr>
              <p:cNvSpPr/>
              <p:nvPr/>
            </p:nvSpPr>
            <p:spPr>
              <a:xfrm>
                <a:off x="2145902" y="4806690"/>
                <a:ext cx="191589" cy="12192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FDACD62-DD0C-48F8-ACEB-B8B041885AE9}"/>
                  </a:ext>
                </a:extLst>
              </p:cNvPr>
              <p:cNvSpPr txBox="1"/>
              <p:nvPr/>
            </p:nvSpPr>
            <p:spPr>
              <a:xfrm>
                <a:off x="2285237" y="4744540"/>
                <a:ext cx="1587294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oncordant match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5D372098-4368-46A6-A570-AC027DD45F0E}"/>
                </a:ext>
              </a:extLst>
            </p:cNvPr>
            <p:cNvGrpSpPr/>
            <p:nvPr/>
          </p:nvGrpSpPr>
          <p:grpSpPr>
            <a:xfrm>
              <a:off x="4646830" y="640080"/>
              <a:ext cx="1535657" cy="246221"/>
              <a:chOff x="1563188" y="4390002"/>
              <a:chExt cx="1535657" cy="246221"/>
            </a:xfrm>
          </p:grpSpPr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1259F5F1-18A4-4A58-A0E6-1E1FADCCC771}"/>
                  </a:ext>
                </a:extLst>
              </p:cNvPr>
              <p:cNvSpPr/>
              <p:nvPr/>
            </p:nvSpPr>
            <p:spPr>
              <a:xfrm>
                <a:off x="1563188" y="4452152"/>
                <a:ext cx="191589" cy="121920"/>
              </a:xfrm>
              <a:prstGeom prst="rect">
                <a:avLst/>
              </a:prstGeom>
              <a:solidFill>
                <a:schemeClr val="tx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0F3B588-30ED-41BB-84FF-25C4C004849D}"/>
                  </a:ext>
                </a:extLst>
              </p:cNvPr>
              <p:cNvSpPr txBox="1"/>
              <p:nvPr/>
            </p:nvSpPr>
            <p:spPr>
              <a:xfrm>
                <a:off x="1719941" y="4390002"/>
                <a:ext cx="1378904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gt;1 concordant match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E042C39-68B1-4275-ACEC-E0DF3C55C908}"/>
                </a:ext>
              </a:extLst>
            </p:cNvPr>
            <p:cNvSpPr txBox="1"/>
            <p:nvPr/>
          </p:nvSpPr>
          <p:spPr>
            <a:xfrm rot="16200000">
              <a:off x="-694432" y="1844342"/>
              <a:ext cx="1965603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. paired-end reads (x 1000)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46C8C8A7-4E5D-4438-87C1-473607386F7D}"/>
                </a:ext>
              </a:extLst>
            </p:cNvPr>
            <p:cNvGrpSpPr/>
            <p:nvPr/>
          </p:nvGrpSpPr>
          <p:grpSpPr>
            <a:xfrm>
              <a:off x="411480" y="480470"/>
              <a:ext cx="6035040" cy="3200400"/>
              <a:chOff x="411480" y="480470"/>
              <a:chExt cx="6035040" cy="3200400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:a16="http://schemas.microsoft.com/office/drawing/2014/main" id="{C8225A3C-C949-4ACB-8C7E-A5AE3382C1C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17994699"/>
                  </p:ext>
                </p:extLst>
              </p:nvPr>
            </p:nvGraphicFramePr>
            <p:xfrm>
              <a:off x="411480" y="480470"/>
              <a:ext cx="6035040" cy="3200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C69C5B0B-1621-4BFB-8B43-834FA48B9504}"/>
                  </a:ext>
                </a:extLst>
              </p:cNvPr>
              <p:cNvSpPr/>
              <p:nvPr/>
            </p:nvSpPr>
            <p:spPr>
              <a:xfrm>
                <a:off x="929503" y="3514165"/>
                <a:ext cx="5453368" cy="14224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6F97B97B-3F86-46D0-982F-FDA13649C1DE}"/>
                </a:ext>
              </a:extLst>
            </p:cNvPr>
            <p:cNvGrpSpPr/>
            <p:nvPr/>
          </p:nvGrpSpPr>
          <p:grpSpPr>
            <a:xfrm>
              <a:off x="923527" y="3417649"/>
              <a:ext cx="1860923" cy="246221"/>
              <a:chOff x="923527" y="3409579"/>
              <a:chExt cx="1860923" cy="246221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18D93C5-1311-47AC-8935-D65ED65CDC9F}"/>
                  </a:ext>
                </a:extLst>
              </p:cNvPr>
              <p:cNvSpPr txBox="1"/>
              <p:nvPr/>
            </p:nvSpPr>
            <p:spPr>
              <a:xfrm>
                <a:off x="923527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6829345-CB70-48B0-A455-D209952FE14E}"/>
                  </a:ext>
                </a:extLst>
              </p:cNvPr>
              <p:cNvSpPr txBox="1"/>
              <p:nvPr/>
            </p:nvSpPr>
            <p:spPr>
              <a:xfrm>
                <a:off x="1357422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00C8626-845C-4FC1-ACD5-EB5D4E1F7714}"/>
                  </a:ext>
                </a:extLst>
              </p:cNvPr>
              <p:cNvSpPr txBox="1"/>
              <p:nvPr/>
            </p:nvSpPr>
            <p:spPr>
              <a:xfrm>
                <a:off x="1846891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FF73235-8804-4B3E-8759-144D414F2951}"/>
                  </a:ext>
                </a:extLst>
              </p:cNvPr>
              <p:cNvSpPr txBox="1"/>
              <p:nvPr/>
            </p:nvSpPr>
            <p:spPr>
              <a:xfrm>
                <a:off x="2280786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64AE1F30-DD62-41FF-8E28-2F1822AD08BB}"/>
                </a:ext>
              </a:extLst>
            </p:cNvPr>
            <p:cNvGrpSpPr/>
            <p:nvPr/>
          </p:nvGrpSpPr>
          <p:grpSpPr>
            <a:xfrm>
              <a:off x="2784450" y="3417649"/>
              <a:ext cx="1860923" cy="246221"/>
              <a:chOff x="923527" y="3409579"/>
              <a:chExt cx="1860923" cy="246221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8815BE14-B187-46E1-AAF7-58CE3772FFBF}"/>
                  </a:ext>
                </a:extLst>
              </p:cNvPr>
              <p:cNvSpPr txBox="1"/>
              <p:nvPr/>
            </p:nvSpPr>
            <p:spPr>
              <a:xfrm>
                <a:off x="923527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AB0DD10-6D4A-437E-8B13-064228D2DDAB}"/>
                  </a:ext>
                </a:extLst>
              </p:cNvPr>
              <p:cNvSpPr txBox="1"/>
              <p:nvPr/>
            </p:nvSpPr>
            <p:spPr>
              <a:xfrm>
                <a:off x="1357422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6FA567D-1628-4F22-B5EC-D1643CC7EF25}"/>
                  </a:ext>
                </a:extLst>
              </p:cNvPr>
              <p:cNvSpPr txBox="1"/>
              <p:nvPr/>
            </p:nvSpPr>
            <p:spPr>
              <a:xfrm>
                <a:off x="1846891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DD8B276-E55B-4311-98EF-20D014BD8D88}"/>
                  </a:ext>
                </a:extLst>
              </p:cNvPr>
              <p:cNvSpPr txBox="1"/>
              <p:nvPr/>
            </p:nvSpPr>
            <p:spPr>
              <a:xfrm>
                <a:off x="2280786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4D7413E8-46E6-4B91-95D1-49FBEEDB8A4E}"/>
                </a:ext>
              </a:extLst>
            </p:cNvPr>
            <p:cNvGrpSpPr/>
            <p:nvPr/>
          </p:nvGrpSpPr>
          <p:grpSpPr>
            <a:xfrm>
              <a:off x="4611235" y="3417649"/>
              <a:ext cx="1860923" cy="246221"/>
              <a:chOff x="923527" y="3409579"/>
              <a:chExt cx="1860923" cy="246221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0DC5E16-D88F-42D7-BADC-8D9FA294BA33}"/>
                  </a:ext>
                </a:extLst>
              </p:cNvPr>
              <p:cNvSpPr txBox="1"/>
              <p:nvPr/>
            </p:nvSpPr>
            <p:spPr>
              <a:xfrm>
                <a:off x="923527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267718B-A90E-4FAB-BE13-B721B3F61E1C}"/>
                  </a:ext>
                </a:extLst>
              </p:cNvPr>
              <p:cNvSpPr txBox="1"/>
              <p:nvPr/>
            </p:nvSpPr>
            <p:spPr>
              <a:xfrm>
                <a:off x="1357422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06D74DE-FEF5-43F7-8A82-C5B1B3D4E63D}"/>
                  </a:ext>
                </a:extLst>
              </p:cNvPr>
              <p:cNvSpPr txBox="1"/>
              <p:nvPr/>
            </p:nvSpPr>
            <p:spPr>
              <a:xfrm>
                <a:off x="1846891" y="340957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s.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17B6F58-CFCA-452D-BB93-F50568676805}"/>
                  </a:ext>
                </a:extLst>
              </p:cNvPr>
              <p:cNvSpPr txBox="1"/>
              <p:nvPr/>
            </p:nvSpPr>
            <p:spPr>
              <a:xfrm>
                <a:off x="2280786" y="3409579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sc.</a:t>
                </a:r>
              </a:p>
            </p:txBody>
          </p:sp>
        </p:grp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F90C816-DA8E-407A-A7AC-7591DB6AA32C}"/>
                </a:ext>
              </a:extLst>
            </p:cNvPr>
            <p:cNvCxnSpPr/>
            <p:nvPr/>
          </p:nvCxnSpPr>
          <p:spPr>
            <a:xfrm>
              <a:off x="980142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93072C20-CF4B-4FD9-84CC-9738A5ACED9F}"/>
                </a:ext>
              </a:extLst>
            </p:cNvPr>
            <p:cNvCxnSpPr/>
            <p:nvPr/>
          </p:nvCxnSpPr>
          <p:spPr>
            <a:xfrm>
              <a:off x="1903404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22E9551-B309-413A-B30E-8E9343CE46F6}"/>
                </a:ext>
              </a:extLst>
            </p:cNvPr>
            <p:cNvCxnSpPr/>
            <p:nvPr/>
          </p:nvCxnSpPr>
          <p:spPr>
            <a:xfrm>
              <a:off x="2848289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4A3D5A1-4786-4DE0-9425-10AA0BD24FD2}"/>
                </a:ext>
              </a:extLst>
            </p:cNvPr>
            <p:cNvCxnSpPr/>
            <p:nvPr/>
          </p:nvCxnSpPr>
          <p:spPr>
            <a:xfrm>
              <a:off x="3780687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E66BD80D-29E3-45E7-B723-EBFA3F75D9F9}"/>
                </a:ext>
              </a:extLst>
            </p:cNvPr>
            <p:cNvCxnSpPr/>
            <p:nvPr/>
          </p:nvCxnSpPr>
          <p:spPr>
            <a:xfrm>
              <a:off x="4690004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6079503E-BA0F-4CE2-A9A3-1ACA83620D5B}"/>
                </a:ext>
              </a:extLst>
            </p:cNvPr>
            <p:cNvCxnSpPr/>
            <p:nvPr/>
          </p:nvCxnSpPr>
          <p:spPr>
            <a:xfrm>
              <a:off x="5603183" y="3615898"/>
              <a:ext cx="800847" cy="746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0B6F84E-CEE1-4B86-8899-DE964FE9A883}"/>
                </a:ext>
              </a:extLst>
            </p:cNvPr>
            <p:cNvSpPr txBox="1"/>
            <p:nvPr/>
          </p:nvSpPr>
          <p:spPr>
            <a:xfrm>
              <a:off x="1082246" y="3587945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49FC82C-E305-4894-A814-3318371048CC}"/>
                </a:ext>
              </a:extLst>
            </p:cNvPr>
            <p:cNvSpPr txBox="1"/>
            <p:nvPr/>
          </p:nvSpPr>
          <p:spPr>
            <a:xfrm>
              <a:off x="2950393" y="3587945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D9B9C97-2F06-49CD-BA5A-A5B510C618C5}"/>
                </a:ext>
              </a:extLst>
            </p:cNvPr>
            <p:cNvSpPr txBox="1"/>
            <p:nvPr/>
          </p:nvSpPr>
          <p:spPr>
            <a:xfrm>
              <a:off x="4792108" y="358833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E69CAA4-9727-423A-9AF8-BF01C913BDC9}"/>
                </a:ext>
              </a:extLst>
            </p:cNvPr>
            <p:cNvSpPr txBox="1"/>
            <p:nvPr/>
          </p:nvSpPr>
          <p:spPr>
            <a:xfrm>
              <a:off x="3862754" y="3588338"/>
              <a:ext cx="6367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16D1CCF-CE39-40FC-AD32-5800AF057623}"/>
                </a:ext>
              </a:extLst>
            </p:cNvPr>
            <p:cNvSpPr txBox="1"/>
            <p:nvPr/>
          </p:nvSpPr>
          <p:spPr>
            <a:xfrm>
              <a:off x="5685250" y="3588338"/>
              <a:ext cx="6367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96DB815-3F58-41E2-862A-DD29C3D2D12F}"/>
                </a:ext>
              </a:extLst>
            </p:cNvPr>
            <p:cNvSpPr txBox="1"/>
            <p:nvPr/>
          </p:nvSpPr>
          <p:spPr>
            <a:xfrm>
              <a:off x="1985471" y="3588338"/>
              <a:ext cx="6367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47FD7B07-D2C8-434F-B436-42CD3AC55A02}"/>
                </a:ext>
              </a:extLst>
            </p:cNvPr>
            <p:cNvCxnSpPr/>
            <p:nvPr/>
          </p:nvCxnSpPr>
          <p:spPr>
            <a:xfrm>
              <a:off x="1152622" y="3795829"/>
              <a:ext cx="13853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7833301A-981F-4882-B219-5BAF25E65A06}"/>
                </a:ext>
              </a:extLst>
            </p:cNvPr>
            <p:cNvCxnSpPr/>
            <p:nvPr/>
          </p:nvCxnSpPr>
          <p:spPr>
            <a:xfrm>
              <a:off x="4867999" y="3795829"/>
              <a:ext cx="13853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18A8A0A8-B4A2-4CCB-8DA6-356058B3A2B6}"/>
                </a:ext>
              </a:extLst>
            </p:cNvPr>
            <p:cNvCxnSpPr/>
            <p:nvPr/>
          </p:nvCxnSpPr>
          <p:spPr>
            <a:xfrm>
              <a:off x="3034669" y="3795829"/>
              <a:ext cx="13853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BE45870-1A48-4747-AF7B-4908C7B35A80}"/>
                </a:ext>
              </a:extLst>
            </p:cNvPr>
            <p:cNvSpPr txBox="1"/>
            <p:nvPr/>
          </p:nvSpPr>
          <p:spPr>
            <a:xfrm>
              <a:off x="1593446" y="3763883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 DAI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207FB3E-387A-421F-B480-FE4C911AEDC1}"/>
                </a:ext>
              </a:extLst>
            </p:cNvPr>
            <p:cNvSpPr txBox="1"/>
            <p:nvPr/>
          </p:nvSpPr>
          <p:spPr>
            <a:xfrm>
              <a:off x="3475493" y="3763883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 DAI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A19DE9C-40CC-4AC7-862D-493F919AE362}"/>
                </a:ext>
              </a:extLst>
            </p:cNvPr>
            <p:cNvSpPr txBox="1"/>
            <p:nvPr/>
          </p:nvSpPr>
          <p:spPr>
            <a:xfrm>
              <a:off x="5273557" y="3763883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 DAI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5D5D90D5-0CB9-DFE4-174D-417AF938CB46}"/>
              </a:ext>
            </a:extLst>
          </p:cNvPr>
          <p:cNvSpPr txBox="1"/>
          <p:nvPr/>
        </p:nvSpPr>
        <p:spPr>
          <a:xfrm>
            <a:off x="521771" y="4188279"/>
            <a:ext cx="6035040" cy="1882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Numbers of mapped and unmapped paired-end reads from quality-controlled RNA-Seq libraries from reniform nematode resistant (Res) and susceptibl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s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tton near-isogenic lines. Sequences were mapped against the JGI reference genome assembly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ssypium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rsut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.1. Control (non-infected) and reniform nematode infected root tissues were collected at 5-, 9-, and 13-DAI (days after inoculation).</a:t>
            </a:r>
          </a:p>
        </p:txBody>
      </p:sp>
    </p:spTree>
    <p:extLst>
      <p:ext uri="{BB962C8B-B14F-4D97-AF65-F5344CB8AC3E}">
        <p14:creationId xmlns:p14="http://schemas.microsoft.com/office/powerpoint/2010/main" val="830969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</TotalTime>
  <Words>122</Words>
  <Application>Microsoft Office PowerPoint</Application>
  <PresentationFormat>Letter Paper (8.5x11 in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bben, Martin</dc:creator>
  <cp:lastModifiedBy>Wubben, Martin - REE-ARS</cp:lastModifiedBy>
  <cp:revision>17</cp:revision>
  <dcterms:created xsi:type="dcterms:W3CDTF">2020-02-24T16:50:41Z</dcterms:created>
  <dcterms:modified xsi:type="dcterms:W3CDTF">2024-11-21T22:06:23Z</dcterms:modified>
</cp:coreProperties>
</file>